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6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2910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95387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99147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48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243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2526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8784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5552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3141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3414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65171-FBB8-4963-94F6-F6362E8D5168}" type="datetimeFigureOut">
              <a:rPr lang="en-IN" smtClean="0"/>
              <a:t>29-09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90557-0761-47DE-A8EF-42720E0694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25442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32A297F4-2C4A-5CB6-B8B7-4DB76F7000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5289291"/>
              </p:ext>
            </p:extLst>
          </p:nvPr>
        </p:nvGraphicFramePr>
        <p:xfrm>
          <a:off x="1206500" y="1282700"/>
          <a:ext cx="4445000" cy="5191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6000">
                  <a:extLst>
                    <a:ext uri="{9D8B030D-6E8A-4147-A177-3AD203B41FA5}">
                      <a16:colId xmlns:a16="http://schemas.microsoft.com/office/drawing/2014/main" val="297759069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74877200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448739674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26068530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s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ic acids (mgL</a:t>
                      </a:r>
                      <a:r>
                        <a:rPr lang="en-US" sz="14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05126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ate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ate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mate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2166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HC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.082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00842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2H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215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73622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H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.53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982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4H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.219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94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93605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6H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5.988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34144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7HC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.666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03407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B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8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43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5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23083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2B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12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3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69392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B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868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0684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4BC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42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8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5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74001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6BC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663</a:t>
                      </a:r>
                      <a:endParaRPr lang="en-IN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50382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4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7BC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0454366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7BF1AC0-8821-214D-9FC2-99DA0776EAF0}"/>
              </a:ext>
            </a:extLst>
          </p:cNvPr>
          <p:cNvSpPr txBox="1"/>
          <p:nvPr/>
        </p:nvSpPr>
        <p:spPr>
          <a:xfrm>
            <a:off x="570523" y="622280"/>
            <a:ext cx="597095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: Concentrations of different metabolites identified in both enrichments via Ion Chromatography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6422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73</Words>
  <Application>Microsoft Office PowerPoint</Application>
  <PresentationFormat>A4 Paper (210x297 mm)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ANDA MANDAL</dc:creator>
  <cp:lastModifiedBy>SUNANDA MANDAL</cp:lastModifiedBy>
  <cp:revision>5</cp:revision>
  <dcterms:created xsi:type="dcterms:W3CDTF">2022-08-11T19:48:06Z</dcterms:created>
  <dcterms:modified xsi:type="dcterms:W3CDTF">2022-09-29T16:35:09Z</dcterms:modified>
</cp:coreProperties>
</file>